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3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883FF"/>
    <a:srgbClr val="945200"/>
    <a:srgbClr val="929000"/>
    <a:srgbClr val="4E8F00"/>
    <a:srgbClr val="008F00"/>
    <a:srgbClr val="009051"/>
    <a:srgbClr val="009193"/>
    <a:srgbClr val="005493"/>
    <a:srgbClr val="011893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86"/>
    <p:restoredTop sz="91346"/>
  </p:normalViewPr>
  <p:slideViewPr>
    <p:cSldViewPr snapToGrid="0" snapToObjects="1">
      <p:cViewPr varScale="1">
        <p:scale>
          <a:sx n="111" d="100"/>
          <a:sy n="111" d="100"/>
        </p:scale>
        <p:origin x="6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D70173-829A-C141-A41C-20C47A1CD0BF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9FF145-BE5B-1742-AF6A-40B39A79E6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972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BE665BC-BF9B-7B40-8FB0-9E2ED7264C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FB4DFE5-88B4-8247-B776-70FF8C387E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BEB68E0-4A35-9649-90D6-AE5999D10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5330535-6B6F-A44B-907A-727ABF1D5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C372B07-052F-D64B-9993-A4E2840CD2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7931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59130DA-3FE8-F84D-8415-2DBDADF1C7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CB19B4A-1AE4-BF4B-8DA6-64A0570F1F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5035100-27FD-454A-B8F0-586E5BF5E6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76CDB46-F492-7F4F-A9F6-60CCE6FDB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BB7C18-6D54-6144-80D6-8D843FB7D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0894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1D0DF37-2F99-DC45-AEE5-EC8CD42CF8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ED5BB2C-664D-3D48-9D93-3A119C335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16F7892-5D7B-D043-A4F6-B5EF2EB28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DA2C3C0-17B2-D045-BFCF-9EA10F1BF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FD0A111-0E61-2F4B-B6DF-19DD57EB1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5763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1BE0247-5806-604E-B678-A0F7A3448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035644C-C534-6540-ACCE-996D1AB70E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FEB17D0-1C96-B346-BC1A-88BD85865B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1A9491-888C-FA47-B789-FEF0324B4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237C3D9-CA04-124C-B2E7-22721DF05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8883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6ACBBB-AC3B-7B4D-A013-0009D36F1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4483D95-C2C8-2644-BDA5-8C8E2E8CD6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5EF0C0C-CC17-0645-92FE-D4822A058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1D108C3-32F0-034F-9ACF-262B23914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B5C6820-7DD0-564D-8108-6CC344865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2454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170C3AA-ECAF-E040-AA80-8FC8E30F6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B3A7539-610B-0144-8BDE-BBDB651BFD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2E06E8-0F39-CC4A-AC6A-9E169341BF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168E816-D92D-9643-B63B-4942C924B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DFA600F-3C48-1143-A228-A43FA2B5D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25EC8AE-E4CA-944E-A9D8-EB99A9BA7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8673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DCDE160-D260-1346-B516-367871505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326B68D-9411-7F43-96A8-3D6A74BF4A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48C4129-E603-9840-98B2-5D054EE883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92B44BF-10A2-3840-B1E4-04F96B4689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9BD82D46-2F42-1244-9CA3-BFD94B0D95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1C96B8E-0E2A-4445-BE26-BB6F4FCB1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2B45430-E701-CE46-BC73-03756A75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B48529DA-71E7-3440-85E2-09CD05297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82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E282FBC-FC10-624A-872E-DE1A42C6E2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E07C9627-41FF-B649-B2E4-A61755351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414E775-7EBC-B541-973F-D9B8F8491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9617E2C-2A36-9B4D-8C1E-982CDD46E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6823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3964208-D4F6-E14A-AAC5-46BE07EB7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A83E425C-C385-2543-AE1C-1FAAEE2DF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0FBCEDD8-69F0-3C4E-B1C2-BD9C7B0E4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7057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A99373E-45D7-DA40-9971-DA7654F8E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0927598-B4A5-3A48-A5BD-8324880AAD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E9B22C2-539D-CC4B-8A3E-BA501A42BF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9B79D20-9A2D-D04F-9220-BAF337C4A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9A5E905-777C-CF49-981C-F31B47921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36CC5C4-3342-AA45-B8DF-0053C476C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1938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81053A-6371-354A-9A83-B441906C26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EA0E848-9146-0347-B5DF-A293100134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C9DC45E-3C83-B14C-BA2B-CE90FBC09E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E830EF0-D2C7-354C-8CF8-69DBFF7CA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F1DB3CB0-7516-604B-9559-8180370C8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2E707E5-DF5F-A849-BE38-902283708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4741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53F78AB-71AD-484D-B566-63EA738AB6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0A5E228-37CC-5A44-B43F-6A9ED0861E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7BBBAF7-3093-9D4C-8434-417C07DAA3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6A660-A5A5-7948-8B5E-EA42D2C5C843}" type="datetimeFigureOut">
              <a:rPr lang="fr-FR" smtClean="0"/>
              <a:t>16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9D9F82A-8835-F44A-B936-63BEB4093F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3F44DB-322E-3D4D-A2A4-135A847BDA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AF822-EC92-7148-AE89-418F5ACAF60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4162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1CF1AB94-ED71-E749-A7FA-E18CDEEB9F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137" t="24475" r="46744" b="52862"/>
          <a:stretch/>
        </p:blipFill>
        <p:spPr>
          <a:xfrm>
            <a:off x="1574544" y="2315520"/>
            <a:ext cx="2013735" cy="101023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18487728-19A9-E94E-88C0-9AA880DA6EEB}"/>
              </a:ext>
            </a:extLst>
          </p:cNvPr>
          <p:cNvCxnSpPr/>
          <p:nvPr/>
        </p:nvCxnSpPr>
        <p:spPr>
          <a:xfrm>
            <a:off x="1841674" y="2195600"/>
            <a:ext cx="41096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7F86611C-7654-0B48-804A-C50DE94E9AA2}"/>
              </a:ext>
            </a:extLst>
          </p:cNvPr>
          <p:cNvCxnSpPr/>
          <p:nvPr/>
        </p:nvCxnSpPr>
        <p:spPr>
          <a:xfrm>
            <a:off x="2425589" y="2195600"/>
            <a:ext cx="41096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6E0C1B6D-7D6A-2548-8E4D-F9A1AFF3CBE3}"/>
              </a:ext>
            </a:extLst>
          </p:cNvPr>
          <p:cNvCxnSpPr/>
          <p:nvPr/>
        </p:nvCxnSpPr>
        <p:spPr>
          <a:xfrm>
            <a:off x="2982105" y="2195600"/>
            <a:ext cx="41096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ZoneTexte 11">
            <a:extLst>
              <a:ext uri="{FF2B5EF4-FFF2-40B4-BE49-F238E27FC236}">
                <a16:creationId xmlns:a16="http://schemas.microsoft.com/office/drawing/2014/main" id="{659B9B33-493D-434A-B0F8-291BB84C01B5}"/>
              </a:ext>
            </a:extLst>
          </p:cNvPr>
          <p:cNvSpPr txBox="1"/>
          <p:nvPr/>
        </p:nvSpPr>
        <p:spPr>
          <a:xfrm>
            <a:off x="1718384" y="1889891"/>
            <a:ext cx="657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TE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E4D66A22-0A08-4C43-AA34-3BFE09AEABE5}"/>
              </a:ext>
            </a:extLst>
          </p:cNvPr>
          <p:cNvSpPr txBox="1"/>
          <p:nvPr/>
        </p:nvSpPr>
        <p:spPr>
          <a:xfrm>
            <a:off x="2302299" y="1889890"/>
            <a:ext cx="657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SE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A590B70-6248-3B47-B2A4-CA35FA314F4C}"/>
              </a:ext>
            </a:extLst>
          </p:cNvPr>
          <p:cNvSpPr txBox="1"/>
          <p:nvPr/>
        </p:nvSpPr>
        <p:spPr>
          <a:xfrm>
            <a:off x="2855391" y="1887065"/>
            <a:ext cx="657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IM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50009456-D668-1A41-AA55-D1B3086437F3}"/>
              </a:ext>
            </a:extLst>
          </p:cNvPr>
          <p:cNvSpPr txBox="1"/>
          <p:nvPr/>
        </p:nvSpPr>
        <p:spPr>
          <a:xfrm>
            <a:off x="745764" y="3386649"/>
            <a:ext cx="33596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/>
              <a:t>pNKT25 </a:t>
            </a:r>
            <a:r>
              <a:rPr lang="fr-FR" sz="1000" i="1" dirty="0" err="1"/>
              <a:t>slyD</a:t>
            </a:r>
            <a:r>
              <a:rPr lang="fr-FR" sz="1000" dirty="0"/>
              <a:t>           </a:t>
            </a:r>
            <a:r>
              <a:rPr lang="fr-FR" sz="1000" dirty="0" err="1"/>
              <a:t>wt</a:t>
            </a:r>
            <a:r>
              <a:rPr lang="fr-FR" sz="1000" dirty="0"/>
              <a:t>.    </a:t>
            </a:r>
            <a:r>
              <a:rPr lang="fr-FR" sz="1000" dirty="0" err="1"/>
              <a:t>ppi</a:t>
            </a:r>
            <a:r>
              <a:rPr lang="fr-FR" sz="1000" dirty="0"/>
              <a:t>.  </a:t>
            </a:r>
            <a:r>
              <a:rPr lang="fr-FR" sz="1000" dirty="0" err="1"/>
              <a:t>wt</a:t>
            </a:r>
            <a:r>
              <a:rPr lang="fr-FR" sz="1000" dirty="0"/>
              <a:t>.   </a:t>
            </a:r>
            <a:r>
              <a:rPr lang="fr-FR" sz="1000" dirty="0" err="1"/>
              <a:t>ppi</a:t>
            </a:r>
            <a:r>
              <a:rPr lang="fr-FR" sz="1000" dirty="0"/>
              <a:t>.     </a:t>
            </a:r>
            <a:r>
              <a:rPr lang="fr-FR" sz="1000" dirty="0" err="1"/>
              <a:t>wt</a:t>
            </a:r>
            <a:r>
              <a:rPr lang="fr-FR" sz="1000" dirty="0"/>
              <a:t>.     </a:t>
            </a:r>
            <a:r>
              <a:rPr lang="fr-FR" sz="1000" dirty="0" err="1"/>
              <a:t>ppi</a:t>
            </a:r>
            <a:r>
              <a:rPr lang="fr-FR" sz="1000" dirty="0"/>
              <a:t>.</a:t>
            </a:r>
          </a:p>
          <a:p>
            <a:r>
              <a:rPr lang="fr-FR" sz="1000" dirty="0"/>
              <a:t>pUT18 </a:t>
            </a:r>
            <a:r>
              <a:rPr lang="fr-FR" sz="1000" i="1" dirty="0" err="1"/>
              <a:t>niuD</a:t>
            </a:r>
            <a:r>
              <a:rPr lang="fr-FR" sz="1000" dirty="0"/>
              <a:t> 	  ∆5.    ∆5.    ∆5.    ∆5.    ∆5.    ∆5.	</a:t>
            </a:r>
            <a:endParaRPr lang="fr-FR" sz="1000" baseline="-25000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3032C61-C40B-FC45-9D32-41F0334480F5}"/>
              </a:ext>
            </a:extLst>
          </p:cNvPr>
          <p:cNvSpPr/>
          <p:nvPr/>
        </p:nvSpPr>
        <p:spPr>
          <a:xfrm>
            <a:off x="10315243" y="216196"/>
            <a:ext cx="1276989" cy="509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US" sz="1600" b="1" dirty="0">
                <a:latin typeface="Arial" panose="020B0604020202020204" pitchFamily="34" charset="0"/>
                <a:ea typeface="MS Mincho" panose="02020609040205080304" pitchFamily="49" charset="-128"/>
              </a:rPr>
              <a:t>S6 Figure</a:t>
            </a:r>
            <a:endParaRPr lang="fr-FR" sz="1600" dirty="0">
              <a:latin typeface="Times New Roman" panose="02020603050405020304" pitchFamily="18" charset="0"/>
              <a:ea typeface="MS Mincho" panose="02020609040205080304" pitchFamily="49" charset="-128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56792DD-E756-8844-9C7E-89CABD8BE292}"/>
              </a:ext>
            </a:extLst>
          </p:cNvPr>
          <p:cNvSpPr/>
          <p:nvPr/>
        </p:nvSpPr>
        <p:spPr>
          <a:xfrm>
            <a:off x="678401" y="2586287"/>
            <a:ext cx="7382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>
                <a:sym typeface="Symbol" pitchFamily="2" charset="2"/>
              </a:rPr>
              <a:t>-</a:t>
            </a:r>
            <a:r>
              <a:rPr lang="en-GB" sz="1400" dirty="0" err="1"/>
              <a:t>cyaA</a:t>
            </a:r>
            <a:r>
              <a:rPr lang="en-GB" sz="1400" dirty="0"/>
              <a:t> </a:t>
            </a:r>
            <a:endParaRPr lang="fr-FR" sz="1400" dirty="0"/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A950A4DE-E24E-6E4B-8084-2F5692004716}"/>
              </a:ext>
            </a:extLst>
          </p:cNvPr>
          <p:cNvSpPr txBox="1"/>
          <p:nvPr/>
        </p:nvSpPr>
        <p:spPr>
          <a:xfrm>
            <a:off x="379887" y="1091771"/>
            <a:ext cx="176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52637383-7B5A-E744-9EC5-1EBBFFD69549}"/>
              </a:ext>
            </a:extLst>
          </p:cNvPr>
          <p:cNvSpPr txBox="1"/>
          <p:nvPr/>
        </p:nvSpPr>
        <p:spPr>
          <a:xfrm>
            <a:off x="5347478" y="1091771"/>
            <a:ext cx="1762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B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CD51DDBE-1A9E-2642-9901-BD504423C2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2589" t="24400" r="31688" b="32897"/>
          <a:stretch/>
        </p:blipFill>
        <p:spPr>
          <a:xfrm>
            <a:off x="6480399" y="1469656"/>
            <a:ext cx="1471689" cy="31917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69FC029F-B691-804B-AFF6-CB47002778A0}"/>
              </a:ext>
            </a:extLst>
          </p:cNvPr>
          <p:cNvSpPr txBox="1"/>
          <p:nvPr/>
        </p:nvSpPr>
        <p:spPr>
          <a:xfrm rot="18611720">
            <a:off x="6596068" y="954372"/>
            <a:ext cx="952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SlyD::T25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6BE08093-2F70-F344-BAE5-57AD95EC996E}"/>
              </a:ext>
            </a:extLst>
          </p:cNvPr>
          <p:cNvSpPr txBox="1"/>
          <p:nvPr/>
        </p:nvSpPr>
        <p:spPr>
          <a:xfrm rot="18611720">
            <a:off x="7171277" y="891785"/>
            <a:ext cx="1113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SlyD-PPI::T25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AF85E947-5FA9-E54A-BE09-035DB7505B1B}"/>
              </a:ext>
            </a:extLst>
          </p:cNvPr>
          <p:cNvSpPr txBox="1"/>
          <p:nvPr/>
        </p:nvSpPr>
        <p:spPr>
          <a:xfrm rot="18611720">
            <a:off x="6798991" y="798576"/>
            <a:ext cx="13582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/>
              <a:t>SlyD-∆IF::</a:t>
            </a:r>
            <a:r>
              <a:rPr lang="fr-FR" sz="1200" dirty="0"/>
              <a:t>T25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8AB83468-8536-424D-828C-FE01217F833A}"/>
              </a:ext>
            </a:extLst>
          </p:cNvPr>
          <p:cNvSpPr txBox="1"/>
          <p:nvPr/>
        </p:nvSpPr>
        <p:spPr>
          <a:xfrm rot="18611720">
            <a:off x="7356803" y="705543"/>
            <a:ext cx="1601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SlyD-∆</a:t>
            </a:r>
            <a:r>
              <a:rPr lang="fr-FR" sz="1200" dirty="0" err="1"/>
              <a:t>Cter</a:t>
            </a:r>
            <a:r>
              <a:rPr lang="fr-FR" sz="1200" dirty="0"/>
              <a:t>::T25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3BD28BEE-8CE4-8B4B-9E84-D3968AE6C48F}"/>
              </a:ext>
            </a:extLst>
          </p:cNvPr>
          <p:cNvSpPr txBox="1"/>
          <p:nvPr/>
        </p:nvSpPr>
        <p:spPr>
          <a:xfrm>
            <a:off x="5184906" y="2955619"/>
            <a:ext cx="11871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ym typeface="Symbol" pitchFamily="2" charset="2"/>
              </a:rPr>
              <a:t>-</a:t>
            </a:r>
            <a:r>
              <a:rPr lang="fr-FR" sz="1400" dirty="0"/>
              <a:t>SlyD</a:t>
            </a:r>
          </a:p>
        </p:txBody>
      </p:sp>
      <p:pic>
        <p:nvPicPr>
          <p:cNvPr id="26" name="Image 25">
            <a:extLst>
              <a:ext uri="{FF2B5EF4-FFF2-40B4-BE49-F238E27FC236}">
                <a16:creationId xmlns:a16="http://schemas.microsoft.com/office/drawing/2014/main" id="{AB61789B-6C92-2241-A3FB-4FF53928D10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0096"/>
          <a:stretch/>
        </p:blipFill>
        <p:spPr>
          <a:xfrm>
            <a:off x="8022173" y="2894064"/>
            <a:ext cx="1061761" cy="1723298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676FBD89-20B6-6E47-9CAE-C3859C5F8B7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6352" b="31940"/>
          <a:stretch/>
        </p:blipFill>
        <p:spPr>
          <a:xfrm>
            <a:off x="3628726" y="2460660"/>
            <a:ext cx="1029053" cy="1080826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8C208B0C-0DCD-1B41-B73A-111D4ED9799E}"/>
              </a:ext>
            </a:extLst>
          </p:cNvPr>
          <p:cNvSpPr txBox="1"/>
          <p:nvPr/>
        </p:nvSpPr>
        <p:spPr>
          <a:xfrm>
            <a:off x="3765724" y="2010175"/>
            <a:ext cx="870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MW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ABDD393D-D4AC-0148-ADBD-3382EC1E5717}"/>
              </a:ext>
            </a:extLst>
          </p:cNvPr>
          <p:cNvSpPr txBox="1"/>
          <p:nvPr/>
        </p:nvSpPr>
        <p:spPr>
          <a:xfrm>
            <a:off x="8117624" y="1153326"/>
            <a:ext cx="8708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MW</a:t>
            </a:r>
          </a:p>
        </p:txBody>
      </p:sp>
    </p:spTree>
    <p:extLst>
      <p:ext uri="{BB962C8B-B14F-4D97-AF65-F5344CB8AC3E}">
        <p14:creationId xmlns:p14="http://schemas.microsoft.com/office/powerpoint/2010/main" val="6311088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45</TotalTime>
  <Words>68</Words>
  <Application>Microsoft Macintosh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MS Mincho</vt:lpstr>
      <vt:lpstr>Arial</vt:lpstr>
      <vt:lpstr>Calibri</vt:lpstr>
      <vt:lpstr>Calibri Light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Hilde DE REUSE</cp:lastModifiedBy>
  <cp:revision>238</cp:revision>
  <cp:lastPrinted>2020-03-06T12:46:51Z</cp:lastPrinted>
  <dcterms:created xsi:type="dcterms:W3CDTF">2019-08-20T14:41:05Z</dcterms:created>
  <dcterms:modified xsi:type="dcterms:W3CDTF">2020-12-16T16:57:52Z</dcterms:modified>
</cp:coreProperties>
</file>